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02" y="294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7739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6863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9039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5137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7984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5637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9319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0286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705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891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26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C4E2AB-6C95-4F2D-8DD9-2144A0959D43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01F84-9216-48EB-ADD4-C1D94B7270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8656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2136732"/>
              </p:ext>
            </p:extLst>
          </p:nvPr>
        </p:nvGraphicFramePr>
        <p:xfrm>
          <a:off x="170875" y="845582"/>
          <a:ext cx="6542438" cy="618978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3927">
                  <a:extLst>
                    <a:ext uri="{9D8B030D-6E8A-4147-A177-3AD203B41FA5}">
                      <a16:colId xmlns:a16="http://schemas.microsoft.com/office/drawing/2014/main" xmlns="" val="3748892663"/>
                    </a:ext>
                  </a:extLst>
                </a:gridCol>
                <a:gridCol w="1507992">
                  <a:extLst>
                    <a:ext uri="{9D8B030D-6E8A-4147-A177-3AD203B41FA5}">
                      <a16:colId xmlns:a16="http://schemas.microsoft.com/office/drawing/2014/main" xmlns="" val="1155748055"/>
                    </a:ext>
                  </a:extLst>
                </a:gridCol>
                <a:gridCol w="1300320">
                  <a:extLst>
                    <a:ext uri="{9D8B030D-6E8A-4147-A177-3AD203B41FA5}">
                      <a16:colId xmlns:a16="http://schemas.microsoft.com/office/drawing/2014/main" xmlns="" val="3069145404"/>
                    </a:ext>
                  </a:extLst>
                </a:gridCol>
                <a:gridCol w="1003936">
                  <a:extLst>
                    <a:ext uri="{9D8B030D-6E8A-4147-A177-3AD203B41FA5}">
                      <a16:colId xmlns:a16="http://schemas.microsoft.com/office/drawing/2014/main" xmlns="" val="2163962335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xmlns="" val="2934974097"/>
                    </a:ext>
                  </a:extLst>
                </a:gridCol>
                <a:gridCol w="936103">
                  <a:extLst>
                    <a:ext uri="{9D8B030D-6E8A-4147-A177-3AD203B41FA5}">
                      <a16:colId xmlns:a16="http://schemas.microsoft.com/office/drawing/2014/main" xmlns="" val="883740912"/>
                    </a:ext>
                  </a:extLst>
                </a:gridCol>
              </a:tblGrid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no.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lication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</a:t>
                      </a:r>
                      <a:r>
                        <a:rPr lang="en-US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ctor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67741997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n-US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l-GR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13515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0809514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GFA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316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52307070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GF</a:t>
                      </a:r>
                      <a:r>
                        <a:rPr lang="en-US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ceptor 1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32152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92310081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GF</a:t>
                      </a:r>
                      <a:r>
                        <a:rPr lang="en-US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ceptor 2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2479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44745249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OR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2983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616873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mTOR </a:t>
                      </a:r>
                    </a:p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er2448)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09268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</a:p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51933318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mTOR </a:t>
                      </a:r>
                    </a:p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er2481)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37133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63253536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S6 Ribosomal Protein</a:t>
                      </a:r>
                    </a:p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er240/244)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5364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75170453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T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9272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27445905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i="0" kern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ospho-</a:t>
                      </a:r>
                      <a:r>
                        <a:rPr lang="en-US" altLang="ko-KR" sz="800" b="0" i="0" kern="120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kt</a:t>
                      </a:r>
                      <a:r>
                        <a:rPr lang="en-US" altLang="ko-KR" sz="800" b="0" i="0" kern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Ser473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4060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36128317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44/42 MAPK (Erk1/2) 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9102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26051198"/>
                  </a:ext>
                </a:extLst>
              </a:tr>
              <a:tr h="47126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p44/42 MAPK (Erk1/2)</a:t>
                      </a:r>
                    </a:p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hr202/Tyr204) 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9101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10652910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l-GR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actin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47778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87222182"/>
                  </a:ext>
                </a:extLst>
              </a:tr>
              <a:tr h="3446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mTOR </a:t>
                      </a:r>
                    </a:p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er2481)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4599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57639246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b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</a:t>
                      </a:r>
                      <a:r>
                        <a:rPr lang="en-US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iosci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027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65476290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 Rad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A711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15425870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1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</a:t>
                      </a:r>
                      <a:r>
                        <a:rPr lang="en-US" altLang="ko-KR" sz="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iosci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0274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5963903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l-GR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MA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맑은 고딕"/>
                          <a:cs typeface="Times New Roman" panose="02020603050405020304" pitchFamily="18" charset="0"/>
                        </a:rPr>
                        <a:t>Sigma</a:t>
                      </a:r>
                      <a:r>
                        <a:rPr lang="en-US" altLang="ko-KR" sz="800" b="0" baseline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맑은 고딕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800" b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맑은 고딕"/>
                          <a:cs typeface="Times New Roman" panose="02020603050405020304" pitchFamily="18" charset="0"/>
                        </a:rPr>
                        <a:t>Aldrich, Inc.</a:t>
                      </a:r>
                      <a:endParaRPr lang="ko-KR" altLang="en-US" sz="800" b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맑은 고딕"/>
                          <a:cs typeface="Times New Roman" panose="02020603050405020304" pitchFamily="18" charset="0"/>
                        </a:rPr>
                        <a:t>A2547</a:t>
                      </a:r>
                      <a:endParaRPr lang="ko-KR" altLang="en-US" sz="800" b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68373054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keratin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lent Technologies, Inc.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3515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7189855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B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i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vus Biologicals</a:t>
                      </a:r>
                      <a:endParaRPr lang="ko-KR" altLang="en-US" sz="800" i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100-222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11369536"/>
                  </a:ext>
                </a:extLst>
              </a:tr>
              <a:tr h="218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ko-KR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9A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i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vus Biologicals</a:t>
                      </a:r>
                      <a:endParaRPr lang="ko-KR" altLang="en-US" sz="800" i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110-56893</a:t>
                      </a:r>
                      <a:endParaRPr lang="ko-KR" altLang="en-US" sz="80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fluorescence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80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44295275"/>
                  </a:ext>
                </a:extLst>
              </a:tr>
            </a:tbl>
          </a:graphicData>
        </a:graphic>
      </p:graphicFrame>
      <p:sp>
        <p:nvSpPr>
          <p:cNvPr id="5" name="Rectangle 44"/>
          <p:cNvSpPr/>
          <p:nvPr/>
        </p:nvSpPr>
        <p:spPr>
          <a:xfrm>
            <a:off x="3273009" y="488506"/>
            <a:ext cx="3429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pPr algn="r">
              <a:tabLst>
                <a:tab pos="2971486" algn="ctr"/>
                <a:tab pos="5942970" algn="r"/>
              </a:tabLst>
            </a:pPr>
            <a:r>
              <a:rPr lang="en-US" sz="100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TORC1 and mTORC2 differentially contribute to CNV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164016" y="7257257"/>
            <a:ext cx="28408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Additional </a:t>
            </a:r>
            <a:r>
              <a:rPr lang="en-US" sz="1000" b="1"/>
              <a:t>file </a:t>
            </a:r>
            <a:r>
              <a:rPr lang="en-US" sz="1000" b="1" smtClean="0"/>
              <a:t>2: Table </a:t>
            </a:r>
            <a:r>
              <a:rPr lang="en-US" sz="1000" b="1" dirty="0"/>
              <a:t>S1. </a:t>
            </a:r>
            <a:r>
              <a:rPr lang="en-US" altLang="ko-KR" sz="10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ko-KR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tails on </a:t>
            </a:r>
            <a:r>
              <a:rPr lang="en-US" altLang="ko-KR" sz="10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bodies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525445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42</Words>
  <Application>Microsoft Office PowerPoint</Application>
  <PresentationFormat>A4 Paper (210x297 mm)</PresentationFormat>
  <Paragraphs>1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oswellgirl111@gmail.com</dc:creator>
  <cp:lastModifiedBy>Tose, Junalyn</cp:lastModifiedBy>
  <cp:revision>2</cp:revision>
  <dcterms:created xsi:type="dcterms:W3CDTF">2019-03-30T09:31:30Z</dcterms:created>
  <dcterms:modified xsi:type="dcterms:W3CDTF">2019-06-13T03:14:04Z</dcterms:modified>
</cp:coreProperties>
</file>